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7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61" autoAdjust="0"/>
    <p:restoredTop sz="94994" autoAdjust="0"/>
  </p:normalViewPr>
  <p:slideViewPr>
    <p:cSldViewPr snapToGrid="0">
      <p:cViewPr varScale="1">
        <p:scale>
          <a:sx n="78" d="100"/>
          <a:sy n="78" d="100"/>
        </p:scale>
        <p:origin x="91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7DE432-57AB-4612-A6B2-945A4D45CF96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15D2DE-74B7-42D0-B7F8-574B813AC33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4172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21BF29-5F04-9BA6-8273-54844A81D7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EBAF52C-C2E2-DA8F-B0CF-10AD99FBA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EA0863-AEDF-105C-61C3-EA53C6E3C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844118-4085-E754-6FCC-2506EB418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429D47-15F9-D570-F486-EF1BB5CEE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94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198704-5B37-F5DB-AAB9-83B1D58737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FBF1EA0-CFD8-CB5B-DCD4-D7F896C088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672268-645D-D28A-F67F-AB4F48DFD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73A5C9-A48D-0AA1-B839-7E00C7A7F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EFBB8E-A91C-706F-86C7-E4D6434E7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7687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6AD1F0B-EC79-E9C7-2855-2FF3EF6E14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9AA7E7-F514-F08C-C708-67F75ECB73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6390C6-0523-F9C1-2505-85E73FC4E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8788A8-3DC1-40A5-F936-8DC5FB0E1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78A86D-CCC8-FC59-B14F-D63A20B69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1814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B06325-D148-C7B5-E248-D098BBFE7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D00DAA-A328-048E-1F88-9CC818A4B8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F7BFF3-C1DC-2623-D8F3-9D5A9FB1C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73AB2B-8912-433F-0AD8-06C1BCF0B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4DB182-435F-8D37-F585-99A4798E6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428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6A33E8-4F71-BC1D-1BD7-4A1155617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8195BD-422B-813A-71EC-1BD83BACDF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D5D281-D981-9D52-C888-7841E68C8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2B79B2-5FED-E4A1-CEF2-97F431EA8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6FC0DA-CD4D-FD6D-7AC5-E75AFB30B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42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BBAD12-05FF-9662-55BF-DB8FE1352B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6F9E670-8FA5-A049-D3BA-33616FA396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7D0548-9FD3-DC7B-C05C-C3085FF31C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F6021A3-CD99-23C4-1385-DA36C7DEF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9CB85B-D75F-3660-3705-A0CA698B8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939D1C-00FB-3594-0C4A-DFD5157C9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46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1D10F0-9CF8-8998-76B6-AC9047F308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21185B-579F-8227-8EFF-2D762B379D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CAF87F5-2E2C-5EA9-CBDB-1E6D1B55EE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2D8AEF-8078-39D1-0CE1-22A4DEF26A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449A5B6-2F6B-5231-5310-D09F2A05A7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18940-283B-26F0-59E0-AAA5F779C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A444374-6BCD-6A2F-CB90-E6159F538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33AEB28-D3E1-A9FD-4D20-83FAC7AFE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971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94D060-C9F7-7454-8DF8-2AAD9F38D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8E7E402-F388-8624-EB01-A149EE1A1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E0FD04B-DAFE-F302-5C5D-65C3A31D4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A28FB29-9F34-AF40-2ED2-574101205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494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69CCA6A-B610-B8F4-321B-DD8F7FB72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8B6D515-B8E7-7563-520B-928941781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1BC20A4-BBED-39E2-9065-33D4528ED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526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0A5F83-F9F5-3140-5B18-8A719C3EFC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C93977-1978-0701-C5E4-6B2C65BAC6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3C0151-0D87-F3D9-D6B4-8F1DF40498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EAF6F43-AED6-FC9B-8709-B7303C6A7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CE2B78-99F9-C026-03CA-FA6701287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7BD40A9-5332-CD6C-C470-F993D7B9F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2810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2451CC-F2A1-5239-EF1D-A0CD22634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08C715E-39A8-4A25-6420-A3942E8ACA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B707B6-4CA2-04BC-00BC-E766055FC9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06C63F-FA71-C0D5-A6D6-529A9D865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82EDB34-4531-B8D5-C8DE-FC6D40305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165633C-F9D0-E39B-13B5-A5FA34337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82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FD61E16-FAE0-6FFA-2A09-31889D939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8463DAA-775F-AE8F-23FF-B2919FAAD1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57A707-FE51-36EF-5626-BACD4FB3FC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C4829-2FE4-417B-9E45-77D4707817CA}" type="datetimeFigureOut">
              <a:rPr lang="zh-CN" altLang="en-US" smtClean="0"/>
              <a:t>2024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D1E598-2497-2864-0867-F2561D572B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34C7F1-C307-B11F-268D-E9E5F5EA74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DC3B2D-5202-4CFA-9EA8-E42D286617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475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1A498C3-747F-B384-2C17-DC3F54A885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13"/>
          <a:stretch/>
        </p:blipFill>
        <p:spPr>
          <a:xfrm>
            <a:off x="1420682" y="0"/>
            <a:ext cx="7467680" cy="6513478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73F969C5-DDFD-8F5A-9365-FF41B771B0FE}"/>
              </a:ext>
            </a:extLst>
          </p:cNvPr>
          <p:cNvSpPr txBox="1"/>
          <p:nvPr/>
        </p:nvSpPr>
        <p:spPr>
          <a:xfrm>
            <a:off x="4630420" y="67523"/>
            <a:ext cx="135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48BF072-7009-AD63-AF71-FA165D1A03AF}"/>
              </a:ext>
            </a:extLst>
          </p:cNvPr>
          <p:cNvSpPr txBox="1"/>
          <p:nvPr/>
        </p:nvSpPr>
        <p:spPr>
          <a:xfrm flipH="1">
            <a:off x="7426543" y="80223"/>
            <a:ext cx="409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FAB91AA-7DC7-671B-49D6-60DDBC64A14C}"/>
              </a:ext>
            </a:extLst>
          </p:cNvPr>
          <p:cNvSpPr txBox="1"/>
          <p:nvPr/>
        </p:nvSpPr>
        <p:spPr>
          <a:xfrm>
            <a:off x="225192" y="6513478"/>
            <a:ext cx="1174161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gene structure and domain analysis of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gGT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Note:(A) Structures of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gGT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es. (B) Domains of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gGT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9C81829-1A70-0E81-F46F-BEC66DE5A6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973" r="3403" b="51091"/>
          <a:stretch/>
        </p:blipFill>
        <p:spPr>
          <a:xfrm>
            <a:off x="8967020" y="0"/>
            <a:ext cx="2064774" cy="6371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4292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E86A14-370A-BAC4-2FCC-D1EED2091A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6E33498-04DC-C716-A5D3-E74F1FFFAD45}"/>
              </a:ext>
            </a:extLst>
          </p:cNvPr>
          <p:cNvGrpSpPr/>
          <p:nvPr/>
        </p:nvGrpSpPr>
        <p:grpSpPr>
          <a:xfrm>
            <a:off x="104184" y="260648"/>
            <a:ext cx="12063995" cy="5623081"/>
            <a:chOff x="104184" y="260648"/>
            <a:chExt cx="12063995" cy="5623081"/>
          </a:xfrm>
        </p:grpSpPr>
        <p:pic>
          <p:nvPicPr>
            <p:cNvPr id="9" name="图片 1">
              <a:extLst>
                <a:ext uri="{FF2B5EF4-FFF2-40B4-BE49-F238E27FC236}">
                  <a16:creationId xmlns:a16="http://schemas.microsoft.com/office/drawing/2014/main" id="{7B7A322C-9990-16E1-101F-71D006D8F1A9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84" y="260648"/>
              <a:ext cx="5972980" cy="1045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图片 2">
              <a:extLst>
                <a:ext uri="{FF2B5EF4-FFF2-40B4-BE49-F238E27FC236}">
                  <a16:creationId xmlns:a16="http://schemas.microsoft.com/office/drawing/2014/main" id="{017FAD2F-14E8-B814-EDD5-C7D63B63E7CC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84" y="1529810"/>
              <a:ext cx="5972980" cy="9699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图片 3">
              <a:extLst>
                <a:ext uri="{FF2B5EF4-FFF2-40B4-BE49-F238E27FC236}">
                  <a16:creationId xmlns:a16="http://schemas.microsoft.com/office/drawing/2014/main" id="{CC1A2A06-7F8A-C880-A09D-3391FC23DCAB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84" y="2733667"/>
              <a:ext cx="5972980" cy="10238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图片 4">
              <a:extLst>
                <a:ext uri="{FF2B5EF4-FFF2-40B4-BE49-F238E27FC236}">
                  <a16:creationId xmlns:a16="http://schemas.microsoft.com/office/drawing/2014/main" id="{BDFC04B1-92AC-0A8A-CA9C-84D3944FCC36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84" y="3750905"/>
              <a:ext cx="5972980" cy="10638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" name="图片 5">
              <a:extLst>
                <a:ext uri="{FF2B5EF4-FFF2-40B4-BE49-F238E27FC236}">
                  <a16:creationId xmlns:a16="http://schemas.microsoft.com/office/drawing/2014/main" id="{D303D7B6-B9D8-F416-4AB7-6AF366A3EF56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84" y="4830823"/>
              <a:ext cx="5972980" cy="1027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图片 6">
              <a:extLst>
                <a:ext uri="{FF2B5EF4-FFF2-40B4-BE49-F238E27FC236}">
                  <a16:creationId xmlns:a16="http://schemas.microsoft.com/office/drawing/2014/main" id="{9FC9D120-D5B2-9866-3F49-C70036E129CB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0084" y="305680"/>
              <a:ext cx="5138095" cy="9598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图片 7">
              <a:extLst>
                <a:ext uri="{FF2B5EF4-FFF2-40B4-BE49-F238E27FC236}">
                  <a16:creationId xmlns:a16="http://schemas.microsoft.com/office/drawing/2014/main" id="{67E2006C-36E7-8AEF-8E9D-FB792656B857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0084" y="1565512"/>
              <a:ext cx="5138095" cy="929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图片 8">
              <a:extLst>
                <a:ext uri="{FF2B5EF4-FFF2-40B4-BE49-F238E27FC236}">
                  <a16:creationId xmlns:a16="http://schemas.microsoft.com/office/drawing/2014/main" id="{857D40A2-DF68-0D21-A800-9F8DC580A692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0084" y="2744654"/>
              <a:ext cx="5138095" cy="9754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图片 9">
              <a:extLst>
                <a:ext uri="{FF2B5EF4-FFF2-40B4-BE49-F238E27FC236}">
                  <a16:creationId xmlns:a16="http://schemas.microsoft.com/office/drawing/2014/main" id="{CF936820-1EF4-03E2-5275-A7A2903F2F18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30905" y="3724210"/>
              <a:ext cx="2991415" cy="11100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图片 10">
              <a:extLst>
                <a:ext uri="{FF2B5EF4-FFF2-40B4-BE49-F238E27FC236}">
                  <a16:creationId xmlns:a16="http://schemas.microsoft.com/office/drawing/2014/main" id="{7E0BF16F-5D18-2CF9-626D-ACA314A2C9D9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27230" y="4819868"/>
              <a:ext cx="4628786" cy="10638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文本框 12">
              <a:extLst>
                <a:ext uri="{FF2B5EF4-FFF2-40B4-BE49-F238E27FC236}">
                  <a16:creationId xmlns:a16="http://schemas.microsoft.com/office/drawing/2014/main" id="{02C70E4C-C814-0F81-1590-770DAEF4C7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184" y="446475"/>
              <a:ext cx="58929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1</a:t>
              </a:r>
            </a:p>
          </p:txBody>
        </p:sp>
        <p:sp>
          <p:nvSpPr>
            <p:cNvPr id="20" name="文本框 13">
              <a:extLst>
                <a:ext uri="{FF2B5EF4-FFF2-40B4-BE49-F238E27FC236}">
                  <a16:creationId xmlns:a16="http://schemas.microsoft.com/office/drawing/2014/main" id="{B7493A5D-8104-4A8E-E640-1C92D6CE2F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755" y="1601819"/>
              <a:ext cx="62509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2</a:t>
              </a:r>
            </a:p>
          </p:txBody>
        </p:sp>
        <p:sp>
          <p:nvSpPr>
            <p:cNvPr id="21" name="文本框 14">
              <a:extLst>
                <a:ext uri="{FF2B5EF4-FFF2-40B4-BE49-F238E27FC236}">
                  <a16:creationId xmlns:a16="http://schemas.microsoft.com/office/drawing/2014/main" id="{C9A498A8-D404-91AA-0593-8F2CB3C76E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90898" y="363513"/>
              <a:ext cx="7280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6</a:t>
              </a:r>
            </a:p>
          </p:txBody>
        </p:sp>
        <p:sp>
          <p:nvSpPr>
            <p:cNvPr id="22" name="文本框 15">
              <a:extLst>
                <a:ext uri="{FF2B5EF4-FFF2-40B4-BE49-F238E27FC236}">
                  <a16:creationId xmlns:a16="http://schemas.microsoft.com/office/drawing/2014/main" id="{64223534-51EF-EA81-6663-66F0EABDEA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76675" y="1692625"/>
              <a:ext cx="5982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7</a:t>
              </a:r>
            </a:p>
          </p:txBody>
        </p:sp>
        <p:sp>
          <p:nvSpPr>
            <p:cNvPr id="23" name="文本框 30">
              <a:extLst>
                <a:ext uri="{FF2B5EF4-FFF2-40B4-BE49-F238E27FC236}">
                  <a16:creationId xmlns:a16="http://schemas.microsoft.com/office/drawing/2014/main" id="{5FF1E2C3-F3F5-EBB8-5850-519B847DF8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428" y="2847487"/>
              <a:ext cx="5713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3</a:t>
              </a:r>
              <a:endParaRPr lang="zh-CN" altLang="en-US" sz="1000" dirty="0">
                <a:latin typeface="Times New Roman" panose="02020603050405020304" pitchFamily="18" charset="0"/>
              </a:endParaRPr>
            </a:p>
          </p:txBody>
        </p:sp>
        <p:sp>
          <p:nvSpPr>
            <p:cNvPr id="24" name="文本框 31">
              <a:extLst>
                <a:ext uri="{FF2B5EF4-FFF2-40B4-BE49-F238E27FC236}">
                  <a16:creationId xmlns:a16="http://schemas.microsoft.com/office/drawing/2014/main" id="{C14F4586-DF70-C241-E290-B0657C34AE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755" y="3989234"/>
              <a:ext cx="598245" cy="1536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r>
                <a:rPr lang="en-US" altLang="zh-CN" sz="1000">
                  <a:latin typeface="Times New Roman" panose="02020603050405020304" pitchFamily="18" charset="0"/>
                </a:rPr>
                <a:t>Motif 4</a:t>
              </a:r>
              <a:endParaRPr lang="zh-CN" altLang="en-US" sz="1000">
                <a:latin typeface="Times New Roman" panose="02020603050405020304" pitchFamily="18" charset="0"/>
              </a:endParaRPr>
            </a:p>
          </p:txBody>
        </p:sp>
        <p:sp>
          <p:nvSpPr>
            <p:cNvPr id="25" name="文本框 32">
              <a:extLst>
                <a:ext uri="{FF2B5EF4-FFF2-40B4-BE49-F238E27FC236}">
                  <a16:creationId xmlns:a16="http://schemas.microsoft.com/office/drawing/2014/main" id="{953B3B8A-1301-E6FC-D5EF-ADC34F6A1C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755" y="5006637"/>
              <a:ext cx="625099" cy="1724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r>
                <a:rPr lang="en-US" altLang="zh-CN" sz="1000">
                  <a:latin typeface="Times New Roman" panose="02020603050405020304" pitchFamily="18" charset="0"/>
                </a:rPr>
                <a:t>Motif 5</a:t>
              </a:r>
              <a:endParaRPr lang="zh-CN" altLang="en-US" sz="1000">
                <a:latin typeface="Times New Roman" panose="02020603050405020304" pitchFamily="18" charset="0"/>
              </a:endParaRPr>
            </a:p>
          </p:txBody>
        </p:sp>
        <p:sp>
          <p:nvSpPr>
            <p:cNvPr id="26" name="文本框 35">
              <a:extLst>
                <a:ext uri="{FF2B5EF4-FFF2-40B4-BE49-F238E27FC236}">
                  <a16:creationId xmlns:a16="http://schemas.microsoft.com/office/drawing/2014/main" id="{6C8AF52C-B586-B973-091A-595F36B0E6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57579" y="2794722"/>
              <a:ext cx="617341" cy="1271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r>
                <a:rPr lang="en-US" altLang="zh-CN" sz="1000" dirty="0">
                  <a:latin typeface="Times New Roman" panose="02020603050405020304" pitchFamily="18" charset="0"/>
                </a:rPr>
                <a:t>Motif 8</a:t>
              </a:r>
              <a:endParaRPr lang="zh-CN" altLang="en-US" sz="1000" dirty="0">
                <a:latin typeface="Times New Roman" panose="02020603050405020304" pitchFamily="18" charset="0"/>
              </a:endParaRPr>
            </a:p>
          </p:txBody>
        </p:sp>
        <p:sp>
          <p:nvSpPr>
            <p:cNvPr id="27" name="文本框 36">
              <a:extLst>
                <a:ext uri="{FF2B5EF4-FFF2-40B4-BE49-F238E27FC236}">
                  <a16:creationId xmlns:a16="http://schemas.microsoft.com/office/drawing/2014/main" id="{80A409EE-55D2-BE8A-E947-39A2E605E7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26848" y="3910265"/>
              <a:ext cx="59763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>
                  <a:latin typeface="Times New Roman" panose="02020603050405020304" pitchFamily="18" charset="0"/>
                </a:rPr>
                <a:t>Motif 9</a:t>
              </a:r>
              <a:endParaRPr lang="zh-CN" altLang="en-US" sz="1000">
                <a:latin typeface="Times New Roman" panose="02020603050405020304" pitchFamily="18" charset="0"/>
              </a:endParaRPr>
            </a:p>
          </p:txBody>
        </p:sp>
        <p:sp>
          <p:nvSpPr>
            <p:cNvPr id="28" name="文本框 37">
              <a:extLst>
                <a:ext uri="{FF2B5EF4-FFF2-40B4-BE49-F238E27FC236}">
                  <a16:creationId xmlns:a16="http://schemas.microsoft.com/office/drawing/2014/main" id="{3B71D7A4-57F1-91CF-656B-387051EC07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08964" y="4963885"/>
              <a:ext cx="6659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000">
                  <a:latin typeface="Times New Roman" panose="02020603050405020304" pitchFamily="18" charset="0"/>
                </a:rPr>
                <a:t>Motif 10</a:t>
              </a:r>
              <a:endParaRPr lang="zh-CN" altLang="en-US" sz="1000">
                <a:latin typeface="Times New Roman" panose="02020603050405020304" pitchFamily="18" charset="0"/>
              </a:endParaRP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16E1407F-3697-89BA-8827-F1693EB299FF}"/>
              </a:ext>
            </a:extLst>
          </p:cNvPr>
          <p:cNvSpPr txBox="1"/>
          <p:nvPr/>
        </p:nvSpPr>
        <p:spPr>
          <a:xfrm>
            <a:off x="132080" y="6252081"/>
            <a:ext cx="11846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altLang="zh-CN" sz="18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equences of </a:t>
            </a:r>
            <a:r>
              <a:rPr lang="en-US" altLang="zh-CN" sz="18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gGT</a:t>
            </a:r>
            <a:r>
              <a:rPr lang="en-US" altLang="zh-CN" sz="18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teins</a:t>
            </a:r>
            <a:r>
              <a:rPr lang="en-US" altLang="zh-CN" sz="20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’ </a:t>
            </a:r>
            <a:r>
              <a:rPr lang="en-US" altLang="zh-CN" sz="18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served motifs.  </a:t>
            </a:r>
            <a:endParaRPr lang="zh-CN" altLang="zh-CN" sz="18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5337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0</TotalTime>
  <Words>62</Words>
  <Application>Microsoft Office PowerPoint</Application>
  <PresentationFormat>宽屏</PresentationFormat>
  <Paragraphs>1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fei Wang</dc:creator>
  <cp:lastModifiedBy>Yafei Wang</cp:lastModifiedBy>
  <cp:revision>114</cp:revision>
  <dcterms:created xsi:type="dcterms:W3CDTF">2024-09-22T15:31:08Z</dcterms:created>
  <dcterms:modified xsi:type="dcterms:W3CDTF">2024-12-05T08:29:02Z</dcterms:modified>
</cp:coreProperties>
</file>